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09" r:id="rId3"/>
    <p:sldId id="410" r:id="rId4"/>
    <p:sldId id="411" r:id="rId5"/>
    <p:sldId id="412" r:id="rId6"/>
    <p:sldId id="413" r:id="rId7"/>
    <p:sldId id="428" r:id="rId8"/>
    <p:sldId id="429" r:id="rId9"/>
    <p:sldId id="430" r:id="rId10"/>
    <p:sldId id="431" r:id="rId11"/>
    <p:sldId id="432" r:id="rId12"/>
    <p:sldId id="433" r:id="rId13"/>
    <p:sldId id="434" r:id="rId14"/>
    <p:sldId id="435" r:id="rId15"/>
    <p:sldId id="427" r:id="rId16"/>
    <p:sldId id="436" r:id="rId17"/>
    <p:sldId id="437" r:id="rId18"/>
    <p:sldId id="439" r:id="rId19"/>
    <p:sldId id="440" r:id="rId20"/>
    <p:sldId id="457" r:id="rId21"/>
    <p:sldId id="458" r:id="rId22"/>
    <p:sldId id="459" r:id="rId23"/>
    <p:sldId id="460" r:id="rId24"/>
    <p:sldId id="461" r:id="rId25"/>
    <p:sldId id="463" r:id="rId26"/>
    <p:sldId id="462" r:id="rId27"/>
    <p:sldId id="464" r:id="rId28"/>
    <p:sldId id="469" r:id="rId29"/>
    <p:sldId id="470" r:id="rId30"/>
    <p:sldId id="471" r:id="rId31"/>
    <p:sldId id="472" r:id="rId32"/>
    <p:sldId id="475" r:id="rId33"/>
    <p:sldId id="476" r:id="rId3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3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7" Type="http://schemas.openxmlformats.org/officeDocument/2006/relationships/tableStyles" Target="tableStyles.xml"/><Relationship Id="rId36" Type="http://schemas.openxmlformats.org/officeDocument/2006/relationships/viewProps" Target="viewProps.xml"/><Relationship Id="rId35" Type="http://schemas.openxmlformats.org/officeDocument/2006/relationships/presProps" Target="presProps.xml"/><Relationship Id="rId34" Type="http://schemas.openxmlformats.org/officeDocument/2006/relationships/slide" Target="slides/slide32.xml"/><Relationship Id="rId33" Type="http://schemas.openxmlformats.org/officeDocument/2006/relationships/slide" Target="slides/slide31.xml"/><Relationship Id="rId32" Type="http://schemas.openxmlformats.org/officeDocument/2006/relationships/slide" Target="slides/slide30.xml"/><Relationship Id="rId31" Type="http://schemas.openxmlformats.org/officeDocument/2006/relationships/slide" Target="slides/slide29.xml"/><Relationship Id="rId30" Type="http://schemas.openxmlformats.org/officeDocument/2006/relationships/slide" Target="slides/slide28.xml"/><Relationship Id="rId3" Type="http://schemas.openxmlformats.org/officeDocument/2006/relationships/slide" Target="slides/slide1.xml"/><Relationship Id="rId29" Type="http://schemas.openxmlformats.org/officeDocument/2006/relationships/slide" Target="slides/slide27.xml"/><Relationship Id="rId28" Type="http://schemas.openxmlformats.org/officeDocument/2006/relationships/slide" Target="slides/slide26.xml"/><Relationship Id="rId27" Type="http://schemas.openxmlformats.org/officeDocument/2006/relationships/slide" Target="slides/slide25.xml"/><Relationship Id="rId26" Type="http://schemas.openxmlformats.org/officeDocument/2006/relationships/slide" Target="slides/slide24.xml"/><Relationship Id="rId25" Type="http://schemas.openxmlformats.org/officeDocument/2006/relationships/slide" Target="slides/slide23.xml"/><Relationship Id="rId24" Type="http://schemas.openxmlformats.org/officeDocument/2006/relationships/slide" Target="slides/slide22.xml"/><Relationship Id="rId23" Type="http://schemas.openxmlformats.org/officeDocument/2006/relationships/slide" Target="slides/slide21.xml"/><Relationship Id="rId22" Type="http://schemas.openxmlformats.org/officeDocument/2006/relationships/slide" Target="slides/slide20.xml"/><Relationship Id="rId21" Type="http://schemas.openxmlformats.org/officeDocument/2006/relationships/slide" Target="slides/slide19.xml"/><Relationship Id="rId20" Type="http://schemas.openxmlformats.org/officeDocument/2006/relationships/slide" Target="slides/slide18.xml"/><Relationship Id="rId2" Type="http://schemas.openxmlformats.org/officeDocument/2006/relationships/theme" Target="theme/theme1.xml"/><Relationship Id="rId19" Type="http://schemas.openxmlformats.org/officeDocument/2006/relationships/slide" Target="slides/slide17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tags" Target="../tags/tag65.xml"/><Relationship Id="rId2" Type="http://schemas.openxmlformats.org/officeDocument/2006/relationships/tags" Target="../tags/tag64.xml"/><Relationship Id="rId1" Type="http://schemas.openxmlformats.org/officeDocument/2006/relationships/tags" Target="../tags/tag6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5.xml"/><Relationship Id="rId1" Type="http://schemas.openxmlformats.org/officeDocument/2006/relationships/image" Target="../media/image9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6.xml"/><Relationship Id="rId1" Type="http://schemas.openxmlformats.org/officeDocument/2006/relationships/image" Target="../media/image10.jpe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7.xml"/><Relationship Id="rId1" Type="http://schemas.openxmlformats.org/officeDocument/2006/relationships/image" Target="../media/image11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8.xml"/><Relationship Id="rId1" Type="http://schemas.openxmlformats.org/officeDocument/2006/relationships/image" Target="../media/image12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9.xml"/><Relationship Id="rId1" Type="http://schemas.openxmlformats.org/officeDocument/2006/relationships/image" Target="../media/image13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0.xml"/><Relationship Id="rId1" Type="http://schemas.openxmlformats.org/officeDocument/2006/relationships/image" Target="../media/image14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1.xml"/><Relationship Id="rId1" Type="http://schemas.openxmlformats.org/officeDocument/2006/relationships/image" Target="../media/image15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2.xml"/><Relationship Id="rId1" Type="http://schemas.openxmlformats.org/officeDocument/2006/relationships/image" Target="../media/image16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3.xml"/><Relationship Id="rId1" Type="http://schemas.openxmlformats.org/officeDocument/2006/relationships/image" Target="../media/image17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4.xml"/><Relationship Id="rId1" Type="http://schemas.openxmlformats.org/officeDocument/2006/relationships/image" Target="../media/image1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6.xml"/><Relationship Id="rId1" Type="http://schemas.openxmlformats.org/officeDocument/2006/relationships/image" Target="../media/image1.jpe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5.xml"/><Relationship Id="rId1" Type="http://schemas.openxmlformats.org/officeDocument/2006/relationships/image" Target="../media/image19.jpe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6.xml"/><Relationship Id="rId1" Type="http://schemas.openxmlformats.org/officeDocument/2006/relationships/image" Target="../media/image20.jpe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7.xml"/><Relationship Id="rId1" Type="http://schemas.openxmlformats.org/officeDocument/2006/relationships/image" Target="../media/image21.jpe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8.xml"/><Relationship Id="rId1" Type="http://schemas.openxmlformats.org/officeDocument/2006/relationships/image" Target="../media/image22.jpe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89.xml"/><Relationship Id="rId1" Type="http://schemas.openxmlformats.org/officeDocument/2006/relationships/image" Target="../media/image23.jpe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0.xml"/><Relationship Id="rId1" Type="http://schemas.openxmlformats.org/officeDocument/2006/relationships/image" Target="../media/image24.jpe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1.xml"/><Relationship Id="rId1" Type="http://schemas.openxmlformats.org/officeDocument/2006/relationships/image" Target="../media/image25.jpeg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2.xml"/><Relationship Id="rId1" Type="http://schemas.openxmlformats.org/officeDocument/2006/relationships/image" Target="../media/image26.jpeg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3.xml"/><Relationship Id="rId1" Type="http://schemas.openxmlformats.org/officeDocument/2006/relationships/image" Target="../media/image27.jpe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4.xml"/><Relationship Id="rId1" Type="http://schemas.openxmlformats.org/officeDocument/2006/relationships/image" Target="../media/image2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7.xml"/><Relationship Id="rId1" Type="http://schemas.openxmlformats.org/officeDocument/2006/relationships/image" Target="../media/image2.jpeg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5.xml"/><Relationship Id="rId1" Type="http://schemas.openxmlformats.org/officeDocument/2006/relationships/image" Target="../media/image29.jpeg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6.xml"/><Relationship Id="rId1" Type="http://schemas.openxmlformats.org/officeDocument/2006/relationships/image" Target="../media/image30.jpeg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97.xml"/><Relationship Id="rId1" Type="http://schemas.openxmlformats.org/officeDocument/2006/relationships/image" Target="../media/image3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8.xml"/><Relationship Id="rId1" Type="http://schemas.openxmlformats.org/officeDocument/2006/relationships/image" Target="../media/image3.jpeg"/></Relationships>
</file>

<file path=ppt/slides/_rels/slide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5.xml"/><Relationship Id="rId3" Type="http://schemas.openxmlformats.org/officeDocument/2006/relationships/tags" Target="../tags/tag70.xml"/><Relationship Id="rId2" Type="http://schemas.openxmlformats.org/officeDocument/2006/relationships/image" Target="../media/image4.jpeg"/><Relationship Id="rId1" Type="http://schemas.openxmlformats.org/officeDocument/2006/relationships/tags" Target="../tags/tag69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1.xml"/><Relationship Id="rId1" Type="http://schemas.openxmlformats.org/officeDocument/2006/relationships/image" Target="../media/image5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2.xml"/><Relationship Id="rId1" Type="http://schemas.openxmlformats.org/officeDocument/2006/relationships/image" Target="../media/image6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3.xml"/><Relationship Id="rId1" Type="http://schemas.openxmlformats.org/officeDocument/2006/relationships/image" Target="../media/image7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tags" Target="../tags/tag74.xml"/><Relationship Id="rId1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/>
        <p:txBody>
          <a:bodyPr>
            <a:normAutofit/>
          </a:bodyPr>
          <a:p>
            <a:pPr algn="just"/>
            <a:r>
              <a:rPr lang="en-US" altLang="zh-CN" sz="3200" spc="0">
                <a:latin typeface="Times New Roman" panose="02020603050405020304" charset="0"/>
                <a:cs typeface="Times New Roman" panose="02020603050405020304" charset="0"/>
              </a:rPr>
              <a:t>Development of an in-house rapid antimicrobial susceptibility testing protocol for positive blood culture and its implementation in routine microbiology laboratories</a:t>
            </a:r>
            <a:endParaRPr lang="en-US" altLang="zh-CN" sz="32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/>
        <p:txBody>
          <a:bodyPr/>
          <a:p>
            <a:pPr algn="ctr">
              <a:lnSpc>
                <a:spcPct val="100000"/>
              </a:lnSpc>
              <a:buClrTx/>
              <a:buSzTx/>
              <a:buFontTx/>
            </a:pPr>
            <a:r>
              <a:rPr lang="en-US" altLang="zh-CN" sz="3200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</a:rPr>
              <a:t>supplementary data</a:t>
            </a:r>
            <a:endParaRPr lang="en-US" altLang="zh-CN" sz="3200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3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 S6.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tazidime-avibactam 30-20µg  rAST 4, 6, 8 and 18h </a:t>
            </a:r>
            <a:endParaRPr lang="en-US" altLang="zh-CN" sz="2665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Z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81805" y="1313815"/>
            <a:ext cx="7296150" cy="43624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7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epime 3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FEP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300855" y="1421765"/>
            <a:ext cx="7277100" cy="44069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8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oxitin 3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FO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83380" y="1421765"/>
            <a:ext cx="7302500" cy="44196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9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azolin 3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KZ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58945" y="1313815"/>
            <a:ext cx="7550150" cy="44386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0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levofloxacin 5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LEV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69105" y="1244600"/>
            <a:ext cx="7232650" cy="43688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1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meropenem 1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ME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62120" y="1313815"/>
            <a:ext cx="7315200" cy="43497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66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 S12.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trimethoprim-sulfamethoxazole 1.25-23.75µg  rAST 6, 8 and 18h </a:t>
            </a:r>
            <a:endParaRPr lang="en-US" altLang="zh-CN" sz="2665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SXT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86910" y="1313815"/>
            <a:ext cx="7219950" cy="43942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66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 S13.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piperacillin-tazobactam 100-10µg  rAST 6, 8 and 18h </a:t>
            </a:r>
            <a:endParaRPr lang="en-US" altLang="zh-CN" sz="2665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TZP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83380" y="1282700"/>
            <a:ext cx="7505700" cy="42926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4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aztreonam 30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AT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34840" y="1313815"/>
            <a:ext cx="7245350" cy="43053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5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iprofloxacin 5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CIP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83100" y="1313815"/>
            <a:ext cx="7245350" cy="43307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76345" y="242640"/>
            <a:ext cx="10969200" cy="705600"/>
          </a:xfrm>
        </p:spPr>
        <p:txBody>
          <a:bodyPr>
            <a:normAutofit fontScale="90000"/>
          </a:bodyPr>
          <a:p>
            <a:r>
              <a:rPr lang="en-US" altLang="zh-CN" sz="2665" spc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Times New Roman" panose="02020603050405020304" charset="0"/>
                <a:cs typeface="Times New Roman" panose="02020603050405020304" charset="0"/>
              </a:rPr>
              <a:t>Table S1. Diameter </a:t>
            </a:r>
            <a:r>
              <a:rPr lang="en-US" altLang="zh-CN" sz="2665" spc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distributions of standard </a:t>
            </a:r>
            <a:r>
              <a:rPr lang="en-US" altLang="zh-CN" sz="2665" i="1" spc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E. coli</a:t>
            </a:r>
            <a:r>
              <a:rPr lang="en-US" altLang="zh-CN" sz="2665" spc="0">
                <a:solidFill>
                  <a:schemeClr val="tx1">
                    <a:lumMod val="85000"/>
                    <a:lumOff val="15000"/>
                  </a:schemeClr>
                </a:solidFill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 ATCC 25922 (n=18) in the rAST method</a:t>
            </a:r>
            <a:endParaRPr lang="en-US" altLang="zh-CN" sz="2665" spc="0">
              <a:solidFill>
                <a:schemeClr val="tx1">
                  <a:lumMod val="85000"/>
                  <a:lumOff val="15000"/>
                </a:schemeClr>
              </a:solidFill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13" name="图片 12" descr="2592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932180" y="1163320"/>
            <a:ext cx="8264525" cy="519493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6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gentamicin 10µg  rAST 8 and 18 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C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866640" y="1179195"/>
            <a:ext cx="4410075" cy="533971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7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tazidime-avibactam 30-20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CZ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92625" y="1313815"/>
            <a:ext cx="7213600" cy="43434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8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epime 30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FEP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321810" y="1313815"/>
            <a:ext cx="7353300" cy="44005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19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imipenem 10µg  rAST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IMP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577715" y="1384935"/>
            <a:ext cx="4147185" cy="500570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20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meropenem 10µg  rAST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 descr="ME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78655" y="1313815"/>
            <a:ext cx="4342765" cy="533844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 S21.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P. aeruginosa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piperacillin-tazobactam 100-10µg  rAST 6, 8 and 18h </a:t>
            </a:r>
            <a:endParaRPr lang="en-US" altLang="zh-CN" sz="2665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TZP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49445" y="1285875"/>
            <a:ext cx="7258050" cy="42862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22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. aureus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gentamicin 10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27220" y="1453515"/>
            <a:ext cx="7150100" cy="44005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23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. aureus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lindamycin 2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D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366895" y="1313815"/>
            <a:ext cx="7023100" cy="42799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24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. aureus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erythromycin 15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E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83380" y="1313815"/>
            <a:ext cx="7289800" cy="42989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25 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. aureus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linezolid 30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LZD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83380" y="1313815"/>
            <a:ext cx="7150100" cy="43497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8400" y="512515"/>
            <a:ext cx="10969200" cy="705600"/>
          </a:xfrm>
        </p:spPr>
        <p:txBody>
          <a:bodyPr>
            <a:no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able S2. Diameter distributions of standard P. aeruginosa ATCC 27853 (n=18) in the rAST method</a:t>
            </a:r>
            <a:b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</a:br>
            <a:endParaRPr lang="en-US" altLang="zh-CN" sz="2400" spc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 descr="2785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39470" y="1217930"/>
            <a:ext cx="10506710" cy="427037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</a:rPr>
              <a:t> S26 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. aureus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trimethoprim-sulfamethoxazole 1.25-23.75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2" name="图片 1" descr="SXT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370070" y="1313815"/>
            <a:ext cx="7207250" cy="424180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27 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. aureus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oxitin 3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 descr="FO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53865" y="1443355"/>
            <a:ext cx="7112000" cy="43751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p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S28 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thin growth in the inhibition zone of trimethoprim-sulfamethoxazole (SXT) with 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. coli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(A) and with </a:t>
            </a:r>
            <a:r>
              <a:rPr lang="en-US" altLang="zh-CN" sz="2665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S. aureus </a:t>
            </a:r>
            <a:r>
              <a:rPr lang="en-US" altLang="zh-CN" sz="2665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B)</a:t>
            </a:r>
            <a:endParaRPr lang="en-US" altLang="zh-CN" sz="2665" spc="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3" name="图片 2" descr="SXT圈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73430" y="1572260"/>
            <a:ext cx="9300845" cy="410908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11575" y="608400"/>
            <a:ext cx="10969200" cy="705600"/>
          </a:xfrm>
        </p:spPr>
        <p:txBody>
          <a:bodyPr>
            <a:no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Table S3. Diameter distributions of standard S. aureus ATCC 25923 (n=18) in the rAST method</a:t>
            </a:r>
            <a:br>
              <a:rPr lang="en-US" altLang="zh-CN" sz="2400">
                <a:latin typeface="Times New Roman" panose="02020603050405020304" charset="0"/>
                <a:cs typeface="Times New Roman" panose="02020603050405020304" charset="0"/>
                <a:sym typeface="+mn-ea"/>
              </a:rPr>
            </a:br>
            <a:endParaRPr lang="en-US" altLang="zh-CN" sz="2400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 descr="2592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51205" y="1313815"/>
            <a:ext cx="10690225" cy="370332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ure S1. 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ampicillin 1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preliminary 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breakpoint (PBP) was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 descr="AMP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4182745" y="1421765"/>
            <a:ext cx="7394575" cy="4257675"/>
          </a:xfrm>
          <a:prstGeom prst="rect">
            <a:avLst/>
          </a:prstGeom>
        </p:spPr>
      </p:pic>
    </p:spTree>
    <p:custDataLst>
      <p:tags r:id="rId3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2. 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aztreonam 30µg  rAST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3"/>
          </p:nvPr>
        </p:nvSpPr>
        <p:spPr/>
        <p:txBody>
          <a:bodyPr/>
          <a:p>
            <a:endParaRPr lang="zh-CN" altLang="en-US"/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AT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83380" y="1313815"/>
            <a:ext cx="7560310" cy="451929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3. 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gentamicin 1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N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83380" y="1496695"/>
            <a:ext cx="7579360" cy="4465955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4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otaxime 3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TX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51325" y="1467485"/>
            <a:ext cx="7569200" cy="43751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" name="标题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p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Fig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ur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</a:rPr>
              <a:t> S5.</a:t>
            </a:r>
            <a:r>
              <a:rPr lang="en-US" altLang="zh-CN" sz="2400" i="1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E. coli, K. pneumoniae</a:t>
            </a:r>
            <a:r>
              <a:rPr lang="en-US" altLang="zh-CN" sz="24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and cefuroxime 30µg  rAST 4, 6, 8 and 18h</a:t>
            </a:r>
            <a:r>
              <a:rPr lang="en-US" altLang="zh-CN" sz="2000" spc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 </a:t>
            </a:r>
            <a:endParaRPr lang="en-US" altLang="zh-CN" sz="2000" spc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9" name="内容占位符 8"/>
          <p:cNvSpPr/>
          <p:nvPr>
            <p:ph sz="half" idx="2"/>
          </p:nvPr>
        </p:nvSpPr>
        <p:spPr>
          <a:xfrm>
            <a:off x="608330" y="1854200"/>
            <a:ext cx="3575050" cy="4395470"/>
          </a:xfrm>
        </p:spPr>
        <p:txBody>
          <a:bodyPr/>
          <a:p>
            <a:pPr marL="0" indent="0">
              <a:buNone/>
            </a:pP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The preliminary breakpoint (PBP) w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as</a:t>
            </a:r>
            <a:r>
              <a:rPr lang="en-US" altLang="zh-CN" sz="2000" b="1" spc="0">
                <a:solidFill>
                  <a:schemeClr val="tx1">
                    <a:lumMod val="85000"/>
                    <a:lumOff val="15000"/>
                  </a:schemeClr>
                </a:solidFill>
                <a:latin typeface="Times New Roman" panose="02020603050405020304" charset="0"/>
                <a:cs typeface="Times New Roman" panose="02020603050405020304" charset="0"/>
                <a:sym typeface="+mn-ea"/>
              </a:rPr>
              <a:t> established during the development of the rAST method and for the error calculations in this study.</a:t>
            </a:r>
            <a:endParaRPr lang="en-US" altLang="zh-CN" sz="2000" b="1" spc="0">
              <a:solidFill>
                <a:schemeClr val="tx1">
                  <a:lumMod val="85000"/>
                  <a:lumOff val="15000"/>
                </a:schemeClr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XM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217670" y="1421765"/>
            <a:ext cx="7359650" cy="4375150"/>
          </a:xfrm>
          <a:prstGeom prst="rect">
            <a:avLst/>
          </a:prstGeom>
        </p:spPr>
      </p:pic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ISCONTENTSTITLE" val="0"/>
  <p:tag name="KSO_WM_UNIT_ISNUMDGMTITLE" val="0"/>
  <p:tag name="KSO_WM_UNIT_PRESET_TEXT" val="空白演示"/>
  <p:tag name="KSO_WM_UNIT_NOCLEAR" val="0"/>
  <p:tag name="KSO_WM_UNIT_SHOW_EDIT_AREA_INDICATION" val="1"/>
  <p:tag name="KSO_WM_UNIT_VALUE" val="28"/>
  <p:tag name="KSO_WM_UNIT_HIGHLIGHT" val="0"/>
  <p:tag name="KSO_WM_UNIT_COMPATIBLE" val="0"/>
  <p:tag name="KSO_WM_UNIT_DIAGRAM_ISNUMVISUAL" val="0"/>
  <p:tag name="KSO_WM_UNIT_DIAGRAM_ISREFERUNIT" val="0"/>
  <p:tag name="KSO_WM_UNIT_TYPE" val="a"/>
  <p:tag name="KSO_WM_UNIT_INDEX" val="1"/>
  <p:tag name="KSO_WM_UNIT_ID" val="custom20205081_1*a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64.xml><?xml version="1.0" encoding="utf-8"?>
<p:tagLst xmlns:p="http://schemas.openxmlformats.org/presentationml/2006/main">
  <p:tag name="KSO_WM_UNIT_ISCONTENTSTITLE" val="0"/>
  <p:tag name="KSO_WM_UNIT_ISNUMDGMTITLE" val="0"/>
  <p:tag name="KSO_WM_UNIT_PRESET_TEXT" val="单击输入您的封面副标题"/>
  <p:tag name="KSO_WM_UNIT_NOCLEAR" val="0"/>
  <p:tag name="KSO_WM_UNIT_SHOW_EDIT_AREA_INDICATION" val="1"/>
  <p:tag name="KSO_WM_UNIT_VALUE" val="111"/>
  <p:tag name="KSO_WM_UNIT_HIGHLIGHT" val="0"/>
  <p:tag name="KSO_WM_UNIT_COMPATIBLE" val="0"/>
  <p:tag name="KSO_WM_UNIT_DIAGRAM_ISNUMVISUAL" val="0"/>
  <p:tag name="KSO_WM_UNIT_DIAGRAM_ISREFERUNIT" val="0"/>
  <p:tag name="KSO_WM_UNIT_TYPE" val="b"/>
  <p:tag name="KSO_WM_UNIT_INDEX" val="1"/>
  <p:tag name="KSO_WM_UNIT_ID" val="custom20205081_1*b*1"/>
  <p:tag name="KSO_WM_TEMPLATE_CATEGORY" val="custom"/>
  <p:tag name="KSO_WM_TEMPLATE_INDEX" val="20205081"/>
  <p:tag name="KSO_WM_UNIT_LAYERLEVEL" val="1"/>
  <p:tag name="KSO_WM_TAG_VERSION" val="1.0"/>
  <p:tag name="KSO_WM_BEAUTIFY_FLAG" val="#wm#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9.xml><?xml version="1.0" encoding="utf-8"?>
<p:tagLst xmlns:p="http://schemas.openxmlformats.org/presentationml/2006/main">
  <p:tag name="KSO_WM_UNIT_PLACING_PICTURE_USER_VIEWPORT" val="{&quot;height&quot;:6960,&quot;width&quot;:12090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29</Words>
  <Application>WPS 演示</Application>
  <PresentationFormat>宽屏</PresentationFormat>
  <Paragraphs>120</Paragraphs>
  <Slides>3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2</vt:i4>
      </vt:variant>
    </vt:vector>
  </HeadingPairs>
  <TitlesOfParts>
    <vt:vector size="41" baseType="lpstr">
      <vt:lpstr>Arial</vt:lpstr>
      <vt:lpstr>宋体</vt:lpstr>
      <vt:lpstr>Wingdings</vt:lpstr>
      <vt:lpstr>微软雅黑</vt:lpstr>
      <vt:lpstr>Wingdings</vt:lpstr>
      <vt:lpstr>Times New Roman</vt:lpstr>
      <vt:lpstr>Arial Unicode MS</vt:lpstr>
      <vt:lpstr>Calibri</vt:lpstr>
      <vt:lpstr>Office 主题​​</vt:lpstr>
      <vt:lpstr>Development of an in-house rapid antimicrobial susceptibility testing protocol for positive blood culture and its implementation in routine microbiology laboratories</vt:lpstr>
      <vt:lpstr>Table S1. Diameter distributions of standard E. coli ATCC 25922 (n=18) in the rAST method</vt:lpstr>
      <vt:lpstr>Table S2. Diameter distributions of standard P. aeruginosa ATCC 27853 (n=18) in the rAST method </vt:lpstr>
      <vt:lpstr>Table S3. Diameter distributions of standard S. aureus ATCC 25923 (n=18) in the rAST method </vt:lpstr>
      <vt:lpstr>Fig S1. E. coli, K. pneumoniae and ampicillin 10µg  rAST 4, 6, 8 and 18h </vt:lpstr>
      <vt:lpstr>Fig S2. E. coli, K. pneumoniae and aztreonam 30µg  rAST 6, 8 and 18h </vt:lpstr>
      <vt:lpstr>Fig S3. E. coli, K. pneumoniae and gentamicin 10µg  rAST 4, 6, 8 and 18h </vt:lpstr>
      <vt:lpstr>Fig S4. E. coli, K. pneumoniae and cefotaxime 30µg  rAST 4, 6, 8 and 18h </vt:lpstr>
      <vt:lpstr>Fig S5. E. coli, K. pneumoniae and cefuroxime 30µg  rAST 4, 6, 8 and 18h </vt:lpstr>
      <vt:lpstr>Fig S6. E. coli, K. pneumoniae and ceftazidime-avibactam 30-20µg  rAST 4, 6, 8 and 18h </vt:lpstr>
      <vt:lpstr>Fig S7. E. coli, K. pneumoniae and cefepime 30µg  rAST 4, 6, 8 and 18h </vt:lpstr>
      <vt:lpstr>Fig S8. E. coli, K. pneumoniae and cefoxitin 30µg  rAST 4, 6, 8 and 18h </vt:lpstr>
      <vt:lpstr>Fig S9. E. coli, K. pneumoniae and cefazolin 30µg  rAST 4, 6, 8 and 18h </vt:lpstr>
      <vt:lpstr>Fig S10. E. coli, K. pneumoniae and levofloxacin 5µg  rAST 6, 8 and 18h </vt:lpstr>
      <vt:lpstr>Fig S11. E. coli, K. pneumoniae and meropenem 10µg  rAST 4, 6, 8 and 18h </vt:lpstr>
      <vt:lpstr>Fig S12. E. coli, K. pneumoniae and trimethoprim-sulfamethoxazole 1.25-23.75µg  rAST 6, 8 and 18h </vt:lpstr>
      <vt:lpstr>Fig S13. E. coli, K. pneumoniae and piperacillin-tazobactam 100-10µg  rAST 6, 8 and 18h </vt:lpstr>
      <vt:lpstr>Fig S14. P. aeruginosa and aztreonam 30µg  rAST 6, 8 and 18h </vt:lpstr>
      <vt:lpstr>Fig S15. P. aeruginosa and ciprofloxacin 5µg  rAST 6, 8 and 18h </vt:lpstr>
      <vt:lpstr>Fig S16. P. aeruginosa and gentamicin 10µg  rAST 8 and 18 h </vt:lpstr>
      <vt:lpstr>Fig S17. P. aeruginosa and ceftazidime-avibactam 30-20µg  rAST 6, 8 and 18h </vt:lpstr>
      <vt:lpstr>Fig S18. P. aeruginosa and cefepime 30µg  rAST 6, 8 and 18h </vt:lpstr>
      <vt:lpstr>Fig S19. P. aeruginosa and imipenem 10µg  rAST 8 and 18h </vt:lpstr>
      <vt:lpstr>Fig S20. P. aeruginosa and meropenem 10µg  rAST 8 and 18h </vt:lpstr>
      <vt:lpstr>Fig S21. P. aeruginosa and piperacillin-tazobactam 100-10µg  rAST 6, 8 and 18h </vt:lpstr>
      <vt:lpstr>Fig S22. S. aureus and gentamicin 10µg  rAST 6, 8 and 18h </vt:lpstr>
      <vt:lpstr>Fig S23. S. aureus and clindamycin 2µg  rAST 6, 8 and 18h </vt:lpstr>
      <vt:lpstr>Fig S24. S. aureus and erythromycin 15µg  rAST 6, 8 and 18h </vt:lpstr>
      <vt:lpstr>Fig S25  S. aureus and linezolid 30µg  rAST 6, 8 and 18h </vt:lpstr>
      <vt:lpstr>Fig S26  S. aureus and trimethoprim-sulfamethoxazole 1.25-23.75µg  rAST 6, 8 and 18h </vt:lpstr>
      <vt:lpstr>Fig S27  S. aureus and cefoxitin 30µg  rAST 4, 6, 8 and 18h </vt:lpstr>
      <vt:lpstr>Fig S27  The thin growth in the inhibition zone of trimethoprim-sulfamethoxazole (SXT) with E. coli (A) and with S. aureus (B)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Lab</cp:lastModifiedBy>
  <cp:revision>177</cp:revision>
  <dcterms:created xsi:type="dcterms:W3CDTF">2019-06-19T02:08:00Z</dcterms:created>
  <dcterms:modified xsi:type="dcterms:W3CDTF">2021-07-18T10:55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